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4A1C5-D8A3-4D8B-8B1A-D9B553BC7E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954E9-6222-4C79-9830-3BF1BCF3CF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07F39-B05F-4582-A3AB-3871A65F36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A1593-D09F-4412-885C-FD9510ADDF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26B0F-7852-41FA-A57F-864A25941D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F9D41-8705-4BB3-86D6-D817D3992C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974C0-B725-4A94-BE47-ED8AB2BA73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E6BCA-0140-46EB-9046-39C9EB6AE4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3C7F8-9D7A-4711-95FB-011ABA5359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DEF41-49D1-45E2-AC4B-55B820E3B6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AC900-12ED-43FD-A188-088CAA180C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C2479-9775-40FD-92C6-F9920A55B0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96BA319-F424-4597-A4E6-144E76E3885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3723E8-CE8F-414F-8E53-1718F05FCF3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tretch/>
        </p:blipFill>
        <p:spPr>
          <a:xfrm rot="16200000">
            <a:off x="-578520" y="2098800"/>
            <a:ext cx="7651800" cy="5227920"/>
          </a:xfrm>
          <a:prstGeom prst="rect">
            <a:avLst/>
          </a:prstGeom>
          <a:ln w="0">
            <a:noFill/>
          </a:ln>
        </p:spPr>
      </p:pic>
      <p:sp>
        <p:nvSpPr>
          <p:cNvPr id="42" name="TextBox 9"/>
          <p:cNvSpPr/>
          <p:nvPr/>
        </p:nvSpPr>
        <p:spPr>
          <a:xfrm>
            <a:off x="375480" y="384120"/>
            <a:ext cx="4034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: Influence plots by risk facto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Male circumcision/Muslim relig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363600" y="8435880"/>
            <a:ext cx="5276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ootnote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Each estimate represents the estimated summary odds ratio after the removal of the given study estimat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5" descr=""/>
          <p:cNvPicPr/>
          <p:nvPr/>
        </p:nvPicPr>
        <p:blipFill>
          <a:blip r:embed="rId1"/>
          <a:stretch/>
        </p:blipFill>
        <p:spPr>
          <a:xfrm rot="16200000">
            <a:off x="-353520" y="3036960"/>
            <a:ext cx="7570800" cy="3805200"/>
          </a:xfrm>
          <a:prstGeom prst="rect">
            <a:avLst/>
          </a:prstGeom>
          <a:ln w="0">
            <a:noFill/>
          </a:ln>
        </p:spPr>
      </p:pic>
      <p:sp>
        <p:nvSpPr>
          <p:cNvPr id="45" name="TextBox 6"/>
          <p:cNvSpPr/>
          <p:nvPr/>
        </p:nvSpPr>
        <p:spPr>
          <a:xfrm>
            <a:off x="411840" y="528480"/>
            <a:ext cx="24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History of paying for sex (me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 rot="16200000">
            <a:off x="-504360" y="2634840"/>
            <a:ext cx="9039240" cy="3978360"/>
          </a:xfrm>
          <a:prstGeom prst="rect">
            <a:avLst/>
          </a:prstGeom>
          <a:ln w="0">
            <a:noFill/>
          </a:ln>
        </p:spPr>
      </p:pic>
      <p:sp>
        <p:nvSpPr>
          <p:cNvPr id="47" name="TextBox 1"/>
          <p:cNvSpPr/>
          <p:nvPr/>
        </p:nvSpPr>
        <p:spPr>
          <a:xfrm>
            <a:off x="409680" y="528480"/>
            <a:ext cx="228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Multiple sexual partn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"/>
          <p:cNvSpPr/>
          <p:nvPr/>
        </p:nvSpPr>
        <p:spPr>
          <a:xfrm>
            <a:off x="409680" y="528480"/>
            <a:ext cx="82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HSV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 rot="16200000">
            <a:off x="-603720" y="3087000"/>
            <a:ext cx="8066160" cy="338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1" descr=""/>
          <p:cNvPicPr/>
          <p:nvPr/>
        </p:nvPicPr>
        <p:blipFill>
          <a:blip r:embed="rId1"/>
          <a:stretch/>
        </p:blipFill>
        <p:spPr>
          <a:xfrm rot="16200000">
            <a:off x="-863280" y="2506320"/>
            <a:ext cx="8674200" cy="4336920"/>
          </a:xfrm>
          <a:prstGeom prst="rect">
            <a:avLst/>
          </a:prstGeom>
          <a:ln w="0">
            <a:noFill/>
          </a:ln>
        </p:spPr>
      </p:pic>
      <p:sp>
        <p:nvSpPr>
          <p:cNvPr id="51" name="TextBox 2"/>
          <p:cNvSpPr/>
          <p:nvPr/>
        </p:nvSpPr>
        <p:spPr>
          <a:xfrm>
            <a:off x="414000" y="528480"/>
            <a:ext cx="89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Syphil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1"/>
          <p:cNvSpPr/>
          <p:nvPr/>
        </p:nvSpPr>
        <p:spPr>
          <a:xfrm>
            <a:off x="415440" y="528480"/>
            <a:ext cx="117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Genital ulc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2" descr=""/>
          <p:cNvPicPr/>
          <p:nvPr/>
        </p:nvPicPr>
        <p:blipFill>
          <a:blip r:embed="rId1"/>
          <a:stretch/>
        </p:blipFill>
        <p:spPr>
          <a:xfrm rot="16200000">
            <a:off x="-473760" y="2649960"/>
            <a:ext cx="7920000" cy="429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1T22:38:43Z</dcterms:created>
  <dc:creator>Paul Arora</dc:creator>
  <dc:description/>
  <dc:language>en-US</dc:language>
  <cp:lastModifiedBy>Paul Arora</cp:lastModifiedBy>
  <cp:lastPrinted>2012-02-01T23:36:41Z</cp:lastPrinted>
  <dcterms:modified xsi:type="dcterms:W3CDTF">2012-02-02T02:43:33Z</dcterms:modified>
  <cp:revision>7</cp:revision>
  <dc:subject/>
  <dc:title>Slide 1</dc:title>
</cp:coreProperties>
</file>